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7102475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953611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098635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007997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885411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981892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368303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817811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829130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378350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109106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782513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8CB07-AC0B-4532-86CD-07DA14929D81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3AC6FC-FECF-411E-BF59-01F0A198C418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078520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hyperlink" Target="mailto:laureana.rebordinos@uca.es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6 Imagen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276" y="1771954"/>
            <a:ext cx="3433564" cy="2123088"/>
          </a:xfrm>
          <a:prstGeom prst="rect">
            <a:avLst/>
          </a:prstGeom>
        </p:spPr>
      </p:pic>
      <p:pic>
        <p:nvPicPr>
          <p:cNvPr id="8" name="7 Imagen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44420" y="1777430"/>
            <a:ext cx="3419787" cy="2114568"/>
          </a:xfrm>
          <a:prstGeom prst="rect">
            <a:avLst/>
          </a:prstGeom>
        </p:spPr>
      </p:pic>
      <p:pic>
        <p:nvPicPr>
          <p:cNvPr id="9" name="8 Imagen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-8723" y="3928344"/>
            <a:ext cx="3433564" cy="2123088"/>
          </a:xfrm>
          <a:prstGeom prst="rect">
            <a:avLst/>
          </a:prstGeom>
        </p:spPr>
      </p:pic>
      <p:pic>
        <p:nvPicPr>
          <p:cNvPr id="10" name="9 Imagen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29000" y="3923928"/>
            <a:ext cx="3433565" cy="2123089"/>
          </a:xfrm>
          <a:prstGeom prst="rect">
            <a:avLst/>
          </a:prstGeom>
        </p:spPr>
      </p:pic>
      <p:pic>
        <p:nvPicPr>
          <p:cNvPr id="11" name="10 Imagen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700808" y="6065507"/>
            <a:ext cx="3433564" cy="2123088"/>
          </a:xfrm>
          <a:prstGeom prst="rect">
            <a:avLst/>
          </a:prstGeom>
        </p:spPr>
      </p:pic>
      <p:sp>
        <p:nvSpPr>
          <p:cNvPr id="13" name="12 Rectángulo"/>
          <p:cNvSpPr/>
          <p:nvPr/>
        </p:nvSpPr>
        <p:spPr>
          <a:xfrm>
            <a:off x="0" y="19816"/>
            <a:ext cx="6864207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C </a:t>
            </a:r>
            <a:r>
              <a:rPr lang="es-ES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ics</a:t>
            </a:r>
            <a:endParaRPr lang="es-E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idence for a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bertsonian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sion in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ea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negalensis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up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858) revealed by Zoo-FISH and comparative genome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</a:p>
          <a:p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laya García-Angulo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anuel A. Merlo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ilvia Portela-Bens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aría E. Rodríguez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Emilio 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rcía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hmed 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-Rikabi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homas Liehr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ureana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bordinos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s-E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thor</a:t>
            </a:r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ureana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bordinos</a:t>
            </a:r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s-ES" sz="800" u="sng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7"/>
              </a:rPr>
              <a:t>laureana.rebordinos@uca.es</a:t>
            </a:r>
            <a:r>
              <a:rPr lang="es-ES" sz="8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Área de Genética, Facultad de Ciencias del Mar y Ambientales, Universidad de Cádiz, 11510 Cádiz, </a:t>
            </a:r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ain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77598" y="1045349"/>
            <a:ext cx="67028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es-E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</a:t>
            </a:r>
            <a:r>
              <a:rPr lang="es-E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ent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titive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ements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C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lone.</a:t>
            </a:r>
            <a:endParaRPr lang="es-E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7719228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</TotalTime>
  <Words>9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JBODONZO</cp:lastModifiedBy>
  <cp:revision>6</cp:revision>
  <cp:lastPrinted>2018-01-07T13:19:25Z</cp:lastPrinted>
  <dcterms:created xsi:type="dcterms:W3CDTF">2017-12-28T16:07:31Z</dcterms:created>
  <dcterms:modified xsi:type="dcterms:W3CDTF">2018-11-05T00:41:28Z</dcterms:modified>
</cp:coreProperties>
</file>